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57" r:id="rId3"/>
    <p:sldId id="258" r:id="rId4"/>
    <p:sldId id="259" r:id="rId5"/>
    <p:sldId id="256" r:id="rId6"/>
    <p:sldId id="260" r:id="rId7"/>
    <p:sldId id="262" r:id="rId8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996" autoAdjust="0"/>
    <p:restoredTop sz="94660"/>
  </p:normalViewPr>
  <p:slideViewPr>
    <p:cSldViewPr snapToGrid="0">
      <p:cViewPr varScale="1">
        <p:scale>
          <a:sx n="49" d="100"/>
          <a:sy n="49" d="100"/>
        </p:scale>
        <p:origin x="1712" y="4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16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C36E-DEBB-49B3-9EEC-0D3DA6B4FE6B}" type="datetimeFigureOut">
              <a:rPr kumimoji="1" lang="ja-JP" altLang="en-US" smtClean="0"/>
              <a:pPr/>
              <a:t>2018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BAF9A-13D5-4B42-A36A-5CCC7C4E3F9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1336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C36E-DEBB-49B3-9EEC-0D3DA6B4FE6B}" type="datetimeFigureOut">
              <a:rPr kumimoji="1" lang="ja-JP" altLang="en-US" smtClean="0"/>
              <a:pPr/>
              <a:t>2018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BAF9A-13D5-4B42-A36A-5CCC7C4E3F9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0246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C36E-DEBB-49B3-9EEC-0D3DA6B4FE6B}" type="datetimeFigureOut">
              <a:rPr kumimoji="1" lang="ja-JP" altLang="en-US" smtClean="0"/>
              <a:pPr/>
              <a:t>2018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BAF9A-13D5-4B42-A36A-5CCC7C4E3F9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4007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C36E-DEBB-49B3-9EEC-0D3DA6B4FE6B}" type="datetimeFigureOut">
              <a:rPr kumimoji="1" lang="ja-JP" altLang="en-US" smtClean="0"/>
              <a:pPr/>
              <a:t>2018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BAF9A-13D5-4B42-A36A-5CCC7C4E3F9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2212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C36E-DEBB-49B3-9EEC-0D3DA6B4FE6B}" type="datetimeFigureOut">
              <a:rPr kumimoji="1" lang="ja-JP" altLang="en-US" smtClean="0"/>
              <a:pPr/>
              <a:t>2018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BAF9A-13D5-4B42-A36A-5CCC7C4E3F9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2371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C36E-DEBB-49B3-9EEC-0D3DA6B4FE6B}" type="datetimeFigureOut">
              <a:rPr kumimoji="1" lang="ja-JP" altLang="en-US" smtClean="0"/>
              <a:pPr/>
              <a:t>2018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BAF9A-13D5-4B42-A36A-5CCC7C4E3F9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437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C36E-DEBB-49B3-9EEC-0D3DA6B4FE6B}" type="datetimeFigureOut">
              <a:rPr kumimoji="1" lang="ja-JP" altLang="en-US" smtClean="0"/>
              <a:pPr/>
              <a:t>2018/8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BAF9A-13D5-4B42-A36A-5CCC7C4E3F9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3178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C36E-DEBB-49B3-9EEC-0D3DA6B4FE6B}" type="datetimeFigureOut">
              <a:rPr kumimoji="1" lang="ja-JP" altLang="en-US" smtClean="0"/>
              <a:pPr/>
              <a:t>2018/8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BAF9A-13D5-4B42-A36A-5CCC7C4E3F9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61845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C36E-DEBB-49B3-9EEC-0D3DA6B4FE6B}" type="datetimeFigureOut">
              <a:rPr kumimoji="1" lang="ja-JP" altLang="en-US" smtClean="0"/>
              <a:pPr/>
              <a:t>2018/8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BAF9A-13D5-4B42-A36A-5CCC7C4E3F9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5690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C36E-DEBB-49B3-9EEC-0D3DA6B4FE6B}" type="datetimeFigureOut">
              <a:rPr kumimoji="1" lang="ja-JP" altLang="en-US" smtClean="0"/>
              <a:pPr/>
              <a:t>2018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BAF9A-13D5-4B42-A36A-5CCC7C4E3F9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6683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C36E-DEBB-49B3-9EEC-0D3DA6B4FE6B}" type="datetimeFigureOut">
              <a:rPr kumimoji="1" lang="ja-JP" altLang="en-US" smtClean="0"/>
              <a:pPr/>
              <a:t>2018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BAF9A-13D5-4B42-A36A-5CCC7C4E3F9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8642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46C36E-DEBB-49B3-9EEC-0D3DA6B4FE6B}" type="datetimeFigureOut">
              <a:rPr kumimoji="1" lang="ja-JP" altLang="en-US" smtClean="0"/>
              <a:pPr/>
              <a:t>2018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2BAF9A-13D5-4B42-A36A-5CCC7C4E3F9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27013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png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13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16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7.vml"/><Relationship Id="rId5" Type="http://schemas.openxmlformats.org/officeDocument/2006/relationships/image" Target="../media/image19.emf"/><Relationship Id="rId4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図 2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22611"/>
            <a:ext cx="6858000" cy="6858000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2545307" y="2134267"/>
            <a:ext cx="6030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356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185629" y="2286668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98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715344" y="2206295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359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272064" y="3191182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360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833897" y="3766662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59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2066512" y="3855373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56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666178" y="4867582"/>
            <a:ext cx="6030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134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473670" y="5538597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52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714780" y="4544584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136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590511" y="4819814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55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063634" y="4712907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47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918986" y="503205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46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723368" y="4272331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43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804236" y="2189911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364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357061" y="2840104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63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303246" y="3398958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MN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261467" y="2285094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O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正方形/長方形 20"/>
          <p:cNvSpPr/>
          <p:nvPr/>
        </p:nvSpPr>
        <p:spPr>
          <a:xfrm>
            <a:off x="61546" y="8540501"/>
            <a:ext cx="673972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s between compound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DHODH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top) and the electron density map of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toured at 1.0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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orange) and 0.6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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lue) (bottom left). Th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ranone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ing from AF was found to be cleaved (bottom right) probably caused by incubation of AF at acidic pH during crystallization condition. The black dashed lines represent hydrogen bonds.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MN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otate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ORO) molecules are shown in gray ball and stick models. </a:t>
            </a:r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DHODH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dues which located within 4 Å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inhibitor are shown in ball and stick models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-1" y="-20648"/>
            <a:ext cx="2977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3" name="オブジェクト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1535324"/>
              </p:ext>
            </p:extLst>
          </p:nvPr>
        </p:nvGraphicFramePr>
        <p:xfrm>
          <a:off x="3391318" y="6531685"/>
          <a:ext cx="3409950" cy="1665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6" name="CS ChemDraw Drawing" r:id="rId4" imgW="4695217" imgH="2296268" progId="ChemDraw.Document.6.0">
                  <p:embed/>
                </p:oleObj>
              </mc:Choice>
              <mc:Fallback>
                <p:oleObj name="CS ChemDraw Drawing" r:id="rId4" imgW="4695217" imgH="2296268" progId="ChemDraw.Document.6.0">
                  <p:embed/>
                  <p:pic>
                    <p:nvPicPr>
                      <p:cNvPr id="0" name="Picture 1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91318" y="6531685"/>
                        <a:ext cx="3409950" cy="166528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4" name="図 2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459" b="18491"/>
          <a:stretch/>
        </p:blipFill>
        <p:spPr>
          <a:xfrm>
            <a:off x="61547" y="6376591"/>
            <a:ext cx="3311675" cy="208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13049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0" y="256351"/>
            <a:ext cx="6858000" cy="6858000"/>
            <a:chOff x="0" y="1524000"/>
            <a:chExt cx="6858000" cy="6858000"/>
          </a:xfrm>
        </p:grpSpPr>
        <p:pic>
          <p:nvPicPr>
            <p:cNvPr id="18" name="図 1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524000"/>
              <a:ext cx="6858000" cy="6858000"/>
            </a:xfrm>
            <a:prstGeom prst="rect">
              <a:avLst/>
            </a:prstGeom>
          </p:spPr>
        </p:pic>
        <p:sp>
          <p:nvSpPr>
            <p:cNvPr id="3" name="テキスト ボックス 2"/>
            <p:cNvSpPr txBox="1"/>
            <p:nvPr/>
          </p:nvSpPr>
          <p:spPr>
            <a:xfrm>
              <a:off x="2545307" y="3309583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35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テキスト ボックス 3"/>
            <p:cNvSpPr txBox="1"/>
            <p:nvPr/>
          </p:nvSpPr>
          <p:spPr>
            <a:xfrm>
              <a:off x="3185629" y="3461984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98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3251593" y="4386969"/>
              <a:ext cx="5918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36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3833897" y="4941978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59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2189342" y="5085280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5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1727593" y="6077018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134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2555557" y="6679794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52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2864905" y="5678956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13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3590511" y="5995130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55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3940804" y="6318127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Q47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4918986" y="6289260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4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4716544" y="5454471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43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4865651" y="4122679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364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4295646" y="4029067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63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5372120" y="4738090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62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1303246" y="4574274"/>
              <a:ext cx="5725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MN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261467" y="3460410"/>
              <a:ext cx="593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O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4028973" y="4631272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1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" name="テキスト ボックス 24"/>
          <p:cNvSpPr txBox="1"/>
          <p:nvPr/>
        </p:nvSpPr>
        <p:spPr>
          <a:xfrm>
            <a:off x="-1" y="-20648"/>
            <a:ext cx="2977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図 2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84" t="16796" r="8327" b="19263"/>
          <a:stretch/>
        </p:blipFill>
        <p:spPr>
          <a:xfrm>
            <a:off x="152871" y="6378002"/>
            <a:ext cx="2995486" cy="2227411"/>
          </a:xfrm>
          <a:prstGeom prst="rect">
            <a:avLst/>
          </a:prstGeom>
        </p:spPr>
      </p:pic>
      <p:graphicFrame>
        <p:nvGraphicFramePr>
          <p:cNvPr id="32" name="オブジェクト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4352460"/>
              </p:ext>
            </p:extLst>
          </p:nvPr>
        </p:nvGraphicFramePr>
        <p:xfrm>
          <a:off x="3391318" y="6773524"/>
          <a:ext cx="3297329" cy="14270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9" name="CS ChemDraw Drawing" r:id="rId5" imgW="4447972" imgH="1924455" progId="ChemDraw.Document.6.0">
                  <p:embed/>
                </p:oleObj>
              </mc:Choice>
              <mc:Fallback>
                <p:oleObj name="CS ChemDraw Drawing" r:id="rId5" imgW="4447972" imgH="1924455" progId="ChemDraw.Document.6.0">
                  <p:embed/>
                  <p:pic>
                    <p:nvPicPr>
                      <p:cNvPr id="0" name="Picture 1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91318" y="6773524"/>
                        <a:ext cx="3297329" cy="142703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正方形/長方形 32"/>
          <p:cNvSpPr/>
          <p:nvPr/>
        </p:nvSpPr>
        <p:spPr>
          <a:xfrm>
            <a:off x="61546" y="8540501"/>
            <a:ext cx="673972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s between compound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DHODH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top) and the electron density map of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toured at 2.0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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orange) and 1.0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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blue) (bottom left). The terminal OH group from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bottom right) makes an intermolecular interaction with benzene 2-OH group through hydrogen bond with a water molecule (shown as red sphere)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black dashed lines represent hydrogen bonds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MN and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otate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ORO) molecules are shown in gray ball and stick models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sDHODH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idues which located within 4 Å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inhibitor are shown in ball and stick models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23636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図 1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6351"/>
            <a:ext cx="6858000" cy="6858000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2545307" y="2041934"/>
            <a:ext cx="6030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Y356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185629" y="2194335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98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703236" y="2160111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359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272064" y="3098849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360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833897" y="3674329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59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2066512" y="3763040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56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666178" y="4775249"/>
            <a:ext cx="6030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134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473670" y="5446264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52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714780" y="4452251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136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590511" y="4727481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55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063634" y="4620574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47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885471" y="500260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46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723368" y="4179998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43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4940713" y="2077107"/>
            <a:ext cx="6030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364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004205" y="2544782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63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303246" y="3306625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MN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261467" y="2192761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RO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-1" y="-20648"/>
            <a:ext cx="2977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7" name="図 2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0" t="17565" b="18475"/>
          <a:stretch/>
        </p:blipFill>
        <p:spPr>
          <a:xfrm>
            <a:off x="46541" y="6545611"/>
            <a:ext cx="3050343" cy="2015293"/>
          </a:xfrm>
          <a:prstGeom prst="rect">
            <a:avLst/>
          </a:prstGeom>
        </p:spPr>
      </p:pic>
      <p:graphicFrame>
        <p:nvGraphicFramePr>
          <p:cNvPr id="31" name="オブジェクト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51931848"/>
              </p:ext>
            </p:extLst>
          </p:nvPr>
        </p:nvGraphicFramePr>
        <p:xfrm>
          <a:off x="3205790" y="6776841"/>
          <a:ext cx="3592459" cy="1426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2" name="CS ChemDraw Drawing" r:id="rId5" imgW="4858155" imgH="1925806" progId="ChemDraw.Document.6.0">
                  <p:embed/>
                </p:oleObj>
              </mc:Choice>
              <mc:Fallback>
                <p:oleObj name="CS ChemDraw Drawing" r:id="rId5" imgW="4858155" imgH="1925806" progId="ChemDraw.Document.6.0">
                  <p:embed/>
                  <p:pic>
                    <p:nvPicPr>
                      <p:cNvPr id="0" name="Picture 1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05790" y="6776841"/>
                        <a:ext cx="3592459" cy="142612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" name="正方形/長方形 31"/>
          <p:cNvSpPr/>
          <p:nvPr/>
        </p:nvSpPr>
        <p:spPr>
          <a:xfrm>
            <a:off x="61546" y="8540501"/>
            <a:ext cx="673972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s between compound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ottom right)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DHODH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top) and the electron density map of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toured at 2.0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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blue) (bottom left)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black dashed lines represent hydrogen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nds. FMN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otate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ORO) molecules are shown in gray ball and stick models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sDHODH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idues which located within 4 Å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inhibitor are shown in ball and stick models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67282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0" y="256351"/>
            <a:ext cx="6858000" cy="5879406"/>
            <a:chOff x="0" y="1484244"/>
            <a:chExt cx="6858000" cy="5879406"/>
          </a:xfrm>
        </p:grpSpPr>
        <p:pic>
          <p:nvPicPr>
            <p:cNvPr id="24" name="図 2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b="14270"/>
            <a:stretch/>
          </p:blipFill>
          <p:spPr>
            <a:xfrm>
              <a:off x="0" y="1484244"/>
              <a:ext cx="6858000" cy="5879406"/>
            </a:xfrm>
            <a:prstGeom prst="rect">
              <a:avLst/>
            </a:prstGeom>
          </p:spPr>
        </p:pic>
        <p:sp>
          <p:nvSpPr>
            <p:cNvPr id="3" name="テキスト ボックス 2"/>
            <p:cNvSpPr txBox="1"/>
            <p:nvPr/>
          </p:nvSpPr>
          <p:spPr>
            <a:xfrm>
              <a:off x="2545307" y="3269827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35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テキスト ボックス 3"/>
            <p:cNvSpPr txBox="1"/>
            <p:nvPr/>
          </p:nvSpPr>
          <p:spPr>
            <a:xfrm>
              <a:off x="3185629" y="3422228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98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テキスト ボックス 4"/>
            <p:cNvSpPr txBox="1"/>
            <p:nvPr/>
          </p:nvSpPr>
          <p:spPr>
            <a:xfrm>
              <a:off x="3692871" y="3413831"/>
              <a:ext cx="5918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359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3272064" y="4326742"/>
              <a:ext cx="5918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36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3861193" y="4909045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59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2066512" y="4990933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5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666178" y="6003142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134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2473670" y="6674157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52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2714780" y="5680144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13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3590511" y="5955374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55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4063634" y="5848467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Q47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4966494" y="6253651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4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4743839" y="5421538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43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4899770" y="3332295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364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4063634" y="3832362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63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4857479" y="2776935"/>
              <a:ext cx="6121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111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303246" y="4534518"/>
              <a:ext cx="5725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MN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261467" y="3420654"/>
              <a:ext cx="593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O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5372120" y="4698334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62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" name="テキスト ボックス 25"/>
          <p:cNvSpPr txBox="1"/>
          <p:nvPr/>
        </p:nvSpPr>
        <p:spPr>
          <a:xfrm>
            <a:off x="-1" y="-20648"/>
            <a:ext cx="2977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7" name="図 2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14946" r="1633" b="18794"/>
          <a:stretch/>
        </p:blipFill>
        <p:spPr>
          <a:xfrm>
            <a:off x="12045" y="6485214"/>
            <a:ext cx="2994991" cy="2017470"/>
          </a:xfrm>
          <a:prstGeom prst="rect">
            <a:avLst/>
          </a:prstGeom>
        </p:spPr>
      </p:pic>
      <p:graphicFrame>
        <p:nvGraphicFramePr>
          <p:cNvPr id="31" name="オブジェクト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8569911"/>
              </p:ext>
            </p:extLst>
          </p:nvPr>
        </p:nvGraphicFramePr>
        <p:xfrm>
          <a:off x="2967251" y="6762431"/>
          <a:ext cx="3869837" cy="14358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5" name="CS ChemDraw Drawing" r:id="rId5" imgW="5185653" imgH="1924455" progId="ChemDraw.Document.6.0">
                  <p:embed/>
                </p:oleObj>
              </mc:Choice>
              <mc:Fallback>
                <p:oleObj name="CS ChemDraw Drawing" r:id="rId5" imgW="5185653" imgH="1924455" progId="ChemDraw.Document.6.0">
                  <p:embed/>
                  <p:pic>
                    <p:nvPicPr>
                      <p:cNvPr id="0" name="Picture 1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67251" y="6762431"/>
                        <a:ext cx="3869837" cy="1435852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" name="正方形/長方形 31"/>
          <p:cNvSpPr/>
          <p:nvPr/>
        </p:nvSpPr>
        <p:spPr>
          <a:xfrm>
            <a:off x="61546" y="8540501"/>
            <a:ext cx="673972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s between compound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ottom right)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DHODH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top) and the electron density map of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toured at 2.0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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blue) (bottom left)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black dashed lines represent hydrogen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nds. FMN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otate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ORO) molecules are shown in gray ball and stick models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sDHODH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idues which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located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in 4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Å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inhibitor are shown in ball and stick models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2313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/>
          <p:cNvGrpSpPr/>
          <p:nvPr/>
        </p:nvGrpSpPr>
        <p:grpSpPr>
          <a:xfrm>
            <a:off x="2850" y="256351"/>
            <a:ext cx="6858000" cy="6858000"/>
            <a:chOff x="0" y="1524000"/>
            <a:chExt cx="6858000" cy="6858000"/>
          </a:xfrm>
        </p:grpSpPr>
        <p:pic>
          <p:nvPicPr>
            <p:cNvPr id="30" name="図 2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524000"/>
              <a:ext cx="6858000" cy="6858000"/>
            </a:xfrm>
            <a:prstGeom prst="rect">
              <a:avLst/>
            </a:prstGeom>
          </p:spPr>
        </p:pic>
        <p:sp>
          <p:nvSpPr>
            <p:cNvPr id="2" name="テキスト ボックス 1"/>
            <p:cNvSpPr txBox="1"/>
            <p:nvPr/>
          </p:nvSpPr>
          <p:spPr>
            <a:xfrm>
              <a:off x="2545307" y="3309583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35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テキスト ボックス 4"/>
            <p:cNvSpPr txBox="1"/>
            <p:nvPr/>
          </p:nvSpPr>
          <p:spPr>
            <a:xfrm>
              <a:off x="3185629" y="3461984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98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3761110" y="3474058"/>
              <a:ext cx="5918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359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3272064" y="4366498"/>
              <a:ext cx="5918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36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3833897" y="4941978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59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2066512" y="5030689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5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1666178" y="6042898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134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2473670" y="6713913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52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2714780" y="5719900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13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3590511" y="5995130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55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4063634" y="5888223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Q47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4850747" y="6316556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4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4723368" y="5447647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43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5529997" y="4500770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38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6099230" y="4834284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67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5444425" y="5354388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62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4940713" y="3344756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364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4281998" y="3974476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63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4789240" y="2830339"/>
              <a:ext cx="6121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111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1303246" y="4574274"/>
              <a:ext cx="5725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MN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261467" y="3460410"/>
              <a:ext cx="593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O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5431439" y="414706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2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4028973" y="4631272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1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1" name="テキスト ボックス 30"/>
          <p:cNvSpPr txBox="1"/>
          <p:nvPr/>
        </p:nvSpPr>
        <p:spPr>
          <a:xfrm>
            <a:off x="-1" y="-20648"/>
            <a:ext cx="2977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2" name="図 3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159" b="20642"/>
          <a:stretch/>
        </p:blipFill>
        <p:spPr>
          <a:xfrm>
            <a:off x="36028" y="6504858"/>
            <a:ext cx="3243403" cy="1984940"/>
          </a:xfrm>
          <a:prstGeom prst="rect">
            <a:avLst/>
          </a:prstGeom>
        </p:spPr>
      </p:pic>
      <p:graphicFrame>
        <p:nvGraphicFramePr>
          <p:cNvPr id="36" name="オブジェクト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1116563"/>
              </p:ext>
            </p:extLst>
          </p:nvPr>
        </p:nvGraphicFramePr>
        <p:xfrm>
          <a:off x="3272051" y="6758524"/>
          <a:ext cx="3440794" cy="14436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28" name="CS ChemDraw Drawing" r:id="rId5" imgW="4586862" imgH="1924455" progId="ChemDraw.Document.6.0">
                  <p:embed/>
                </p:oleObj>
              </mc:Choice>
              <mc:Fallback>
                <p:oleObj name="CS ChemDraw Drawing" r:id="rId5" imgW="4586862" imgH="1924455" progId="ChemDraw.Document.6.0">
                  <p:embed/>
                  <p:pic>
                    <p:nvPicPr>
                      <p:cNvPr id="0" name="Picture 1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72051" y="6758524"/>
                        <a:ext cx="3440794" cy="1443666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正方形/長方形 36"/>
          <p:cNvSpPr/>
          <p:nvPr/>
        </p:nvSpPr>
        <p:spPr>
          <a:xfrm>
            <a:off x="61546" y="8540501"/>
            <a:ext cx="673972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s between compound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DHODH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top) and the electron density map of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toured at 2.0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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blue) (bottom left). The benzene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-OH group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ottom right)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acts with Leu359 though water molecule (W1) and the terminal ester carbonyl group interacts with Tyr38 though another water molecule (W2), shown as red spheres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black dashed lines represent hydrogen bonds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MN and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otate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ORO) molecules are shown in gray ball and stick models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sDHODH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idues which located within 4 Å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inhibitor are shown in ball and stick models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23950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0" y="250807"/>
            <a:ext cx="6858000" cy="5871697"/>
            <a:chOff x="0" y="1524000"/>
            <a:chExt cx="6858000" cy="5871697"/>
          </a:xfrm>
        </p:grpSpPr>
        <p:pic>
          <p:nvPicPr>
            <p:cNvPr id="23" name="図 2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4382"/>
            <a:stretch/>
          </p:blipFill>
          <p:spPr>
            <a:xfrm>
              <a:off x="0" y="1524000"/>
              <a:ext cx="6858000" cy="5871697"/>
            </a:xfrm>
            <a:prstGeom prst="rect">
              <a:avLst/>
            </a:prstGeom>
          </p:spPr>
        </p:pic>
        <p:sp>
          <p:nvSpPr>
            <p:cNvPr id="3" name="テキスト ボックス 2"/>
            <p:cNvSpPr txBox="1"/>
            <p:nvPr/>
          </p:nvSpPr>
          <p:spPr>
            <a:xfrm>
              <a:off x="2545307" y="3309583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35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テキスト ボックス 3"/>
            <p:cNvSpPr txBox="1"/>
            <p:nvPr/>
          </p:nvSpPr>
          <p:spPr>
            <a:xfrm>
              <a:off x="3185629" y="3461984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98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テキスト ボックス 4"/>
            <p:cNvSpPr txBox="1"/>
            <p:nvPr/>
          </p:nvSpPr>
          <p:spPr>
            <a:xfrm>
              <a:off x="3686048" y="3460411"/>
              <a:ext cx="5918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359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3272064" y="4366498"/>
              <a:ext cx="5918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36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3833897" y="4941978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59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2243933" y="5133047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5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666178" y="6042898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134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2473670" y="6713913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52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2714780" y="5719900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13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3590511" y="5995130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55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4052060" y="5946097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Q47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4924341" y="6241493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4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4723368" y="5447647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43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4947537" y="3372051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364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4350237" y="4008595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63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303246" y="4574274"/>
              <a:ext cx="5725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MN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261467" y="3460410"/>
              <a:ext cx="593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O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5372120" y="4738090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62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3994186" y="6988377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5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4521157" y="5780435"/>
              <a:ext cx="4924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58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" name="テキスト ボックス 26"/>
          <p:cNvSpPr txBox="1"/>
          <p:nvPr/>
        </p:nvSpPr>
        <p:spPr>
          <a:xfrm>
            <a:off x="-1" y="-20648"/>
            <a:ext cx="2977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8" name="図 2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410" r="9007" b="18328"/>
          <a:stretch/>
        </p:blipFill>
        <p:spPr>
          <a:xfrm>
            <a:off x="1" y="6387548"/>
            <a:ext cx="2888974" cy="2103728"/>
          </a:xfrm>
          <a:prstGeom prst="rect">
            <a:avLst/>
          </a:prstGeom>
        </p:spPr>
      </p:pic>
      <p:graphicFrame>
        <p:nvGraphicFramePr>
          <p:cNvPr id="31" name="オブジェクト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6099482"/>
              </p:ext>
            </p:extLst>
          </p:nvPr>
        </p:nvGraphicFramePr>
        <p:xfrm>
          <a:off x="2880648" y="6744286"/>
          <a:ext cx="3960257" cy="14694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1" name="CS ChemDraw Drawing" r:id="rId5" imgW="5184302" imgH="1924455" progId="ChemDraw.Document.6.0">
                  <p:embed/>
                </p:oleObj>
              </mc:Choice>
              <mc:Fallback>
                <p:oleObj name="CS ChemDraw Drawing" r:id="rId5" imgW="5184302" imgH="1924455" progId="ChemDraw.Document.6.0">
                  <p:embed/>
                  <p:pic>
                    <p:nvPicPr>
                      <p:cNvPr id="0" name="Picture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80648" y="6744286"/>
                        <a:ext cx="3960257" cy="1469401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" name="正方形/長方形 31"/>
          <p:cNvSpPr/>
          <p:nvPr/>
        </p:nvSpPr>
        <p:spPr>
          <a:xfrm>
            <a:off x="61546" y="8540501"/>
            <a:ext cx="673972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s between compound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ottom right)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DHODH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top) and the electron density map of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toured at 2.0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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blue) (bottom left)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black dashed lines represent hydrogen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nds. FMN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otate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ORO) molecules are shown in gray ball and stick models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sDHODH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idues which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located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in 4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Å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inhibitor are shown in ball and stick models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47779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96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905" t="18109" b="62475"/>
          <a:stretch/>
        </p:blipFill>
        <p:spPr bwMode="auto">
          <a:xfrm>
            <a:off x="2144851" y="4715433"/>
            <a:ext cx="2568298" cy="5953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5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1856917"/>
              </p:ext>
            </p:extLst>
          </p:nvPr>
        </p:nvGraphicFramePr>
        <p:xfrm>
          <a:off x="293440" y="2501426"/>
          <a:ext cx="6271119" cy="43800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556" name="Prism 7" r:id="rId4" imgW="4079617" imgH="2849539" progId="">
                  <p:embed/>
                </p:oleObj>
              </mc:Choice>
              <mc:Fallback>
                <p:oleObj name="Prism 7" r:id="rId4" imgW="4079617" imgH="2849539" progId="">
                  <p:embed/>
                  <p:pic>
                    <p:nvPicPr>
                      <p:cNvPr id="0" name="Picture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3440" y="2501426"/>
                        <a:ext cx="6271119" cy="4380021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-1" y="-20648"/>
            <a:ext cx="2977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61546" y="8540501"/>
            <a:ext cx="673972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A771726 (</a:t>
            </a:r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riflunomide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a known HsDHODH inhibitor, on DLD-1 cells under hypoxia/nutrient-deprived conditions. Note that the growth inhibition begun only at high concentrations (100 </a:t>
            </a:r>
            <a:r>
              <a:rPr lang="en-US" altLang="ja-JP" sz="1200" dirty="0" smtClean="0">
                <a:latin typeface="Times New Roman"/>
                <a:cs typeface="Times New Roman"/>
              </a:rPr>
              <a:t>µ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). This is probably due to its low inhibition potency against HsDHODH with an IC</a:t>
            </a:r>
            <a:r>
              <a:rPr lang="en-US" altLang="ja-JP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773 nM, which is over 100 times higher than the IC</a:t>
            </a:r>
            <a:r>
              <a:rPr lang="en-US" altLang="ja-JP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ascofuranone and its derivatives. Hence, similar magnitude of shift in the growth inhibition can be expected.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2</TotalTime>
  <Words>746</Words>
  <Application>Microsoft Office PowerPoint</Application>
  <PresentationFormat>A4 210 x 297 mm</PresentationFormat>
  <Paragraphs>128</Paragraphs>
  <Slides>7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2</vt:i4>
      </vt:variant>
      <vt:variant>
        <vt:lpstr>スライド タイトル</vt:lpstr>
      </vt:variant>
      <vt:variant>
        <vt:i4>7</vt:i4>
      </vt:variant>
    </vt:vector>
  </HeadingPairs>
  <TitlesOfParts>
    <vt:vector size="16" baseType="lpstr">
      <vt:lpstr>ＭＳ Ｐゴシック</vt:lpstr>
      <vt:lpstr>Arial</vt:lpstr>
      <vt:lpstr>Calibri</vt:lpstr>
      <vt:lpstr>Calibri Light</vt:lpstr>
      <vt:lpstr>Symbol</vt:lpstr>
      <vt:lpstr>Times New Roman</vt:lpstr>
      <vt:lpstr>Office テーマ</vt:lpstr>
      <vt:lpstr>CS ChemDraw Drawing</vt:lpstr>
      <vt:lpstr>Prism 7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ba</dc:creator>
  <cp:lastModifiedBy>稲岡 健ダニエル</cp:lastModifiedBy>
  <cp:revision>71</cp:revision>
  <cp:lastPrinted>2018-02-14T12:30:20Z</cp:lastPrinted>
  <dcterms:created xsi:type="dcterms:W3CDTF">2018-02-13T10:42:07Z</dcterms:created>
  <dcterms:modified xsi:type="dcterms:W3CDTF">2018-08-01T05:23:18Z</dcterms:modified>
</cp:coreProperties>
</file>